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</p:sldIdLst>
  <p:sldSz cx="12192000" cy="6858000"/>
  <p:notesSz cx="6888163" cy="100203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228" y="64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A5C37C-B4BB-4E5A-8F34-1F6DAED840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7B6ECF9-3919-4F6E-92C7-6CC653C610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A02FFD8-E870-48EE-B9C3-37E764B9D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C3B4A3D-ECEE-4AC8-9AAD-82D099EA9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3784A6-F4B6-4F55-93CB-4608F511D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3647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F5DEC32-D957-41B6-91EE-3E596BD544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0E3D36F-749F-4455-B894-C994BA70A1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0F7F03C-7627-4FE8-99B3-8F0A77377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D7A5337-AC41-48BB-AA9E-7AD68FC40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1FF6836-EFED-4E32-930F-A2B66370A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4075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9E0A332-4028-442A-9694-D8D74B907D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6F5F37E-ACE3-40EE-9707-7CF5ACFFF1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8E48108-6641-4BC1-BAAB-A52F65B81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0797831-50DC-43AB-8E38-3A0162A5C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35D6C1A-FE79-475B-ACD5-B72A17D29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0240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377860-F0DE-4BF4-819E-EFAFCC678A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7E92A4A-34CD-40F5-9E53-CD5A12EC9B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34253C9-6712-40CD-A595-9521F4005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002C4A-00C0-42BD-AAE5-3CAC3A8D3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BB3F7CC-3E78-4024-8730-85BC39450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1788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9839DB-5350-4E8B-906E-E396CB6DF7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38E0905-A2E7-4377-8171-04A9F4329E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542DF1E-7A2A-4708-8212-59DCE2936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8C7AF10-75CD-4053-88B6-72CAF361D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A668136-82FC-45E1-AB48-A7CE2A45D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2806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940E87-7E92-4117-A2E5-46046B19F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7337E62-703F-4319-8AF6-98F76005CD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4B7914E-495B-4CC3-9828-5E44660872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043C97A-637A-445F-88B4-8EBDF6BF1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03D1572-70A2-4AE6-8547-7F23A1398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3073087-5893-462B-9D84-772C7A342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3526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FF297FA-0579-4310-A1A6-882A189D83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3A32081-CFEB-4888-B6B6-0FF314F0C5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A31E6A3-9C6F-4D17-A8D6-A92399AC5A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5A431E3-A6B6-407C-9523-746947ACB4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3043995-64E3-42F4-B63B-3483CEDEDB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9200437-4261-44BB-8ED0-2482DFD44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60F0124-7820-4AB0-9B16-67D77B362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D13BAE9-490A-4F88-B4D0-96C2B9231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0525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AB970C-368B-492E-BBAD-4413100E16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C366E3E-D250-467F-B281-AFB3CB1F7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725508F-7517-4A23-AF56-E922EAFD0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B8BC627-DD25-4609-9C0E-A45B302FB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3483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03E38C5-2BD7-41F7-850E-D08098870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FF99640-CC37-4F32-91A1-A0CDB6D5F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D481D21-0082-46F3-A47B-EDAD4480E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2852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23A75F-6AA6-42BA-9BF1-DAA7E3B36C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A998BF8-8179-4FE5-BA3F-80D8BDAC1F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9CBE222-8D6D-469B-BF64-217A16364C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8EFDF10-C916-4BFA-9547-D728DE7C6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1E0099F-9B71-4446-8678-F7CA834D0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8109485-6617-46B7-B856-AB836C9893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9475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C9FC6A-DD71-4B9B-BF87-C4464B47F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B9A7655-F5A4-409C-8DA8-5C09FFC655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BD097AC-17F7-46A9-BED9-9854DD93FA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C6A06C8-D6B9-4BA7-A8F7-DB64D0A8C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75BDFC2-6057-45E4-9935-EF9974D89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0BDE3A6-2C42-4EE8-9E1F-E56C13568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6385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6EA2FEC-CD61-4372-B340-42BA05CC1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5F6EFF5-4C9E-4B89-B45C-DE0E1B5FC7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A1AD2FF-640D-4B1E-8577-A91F708D85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F0B52-457B-459E-9F54-B8C72802DBB2}" type="datetimeFigureOut">
              <a:rPr lang="de-DE" smtClean="0"/>
              <a:t>15.02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CF09ABF-637A-477A-BACC-5F7B8638EA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9D34E2A-2416-4100-9E80-1945ED5F7F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BD1AB-CDCF-49F7-8794-C9E1EEF1717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5073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EA7997E-D4A8-4DCD-B7DF-F303F84C74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7332" y="1680211"/>
            <a:ext cx="5400000" cy="65273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051FF50-BF53-4D6E-A055-669929B31E1C}"/>
              </a:ext>
            </a:extLst>
          </p:cNvPr>
          <p:cNvSpPr txBox="1"/>
          <p:nvPr/>
        </p:nvSpPr>
        <p:spPr>
          <a:xfrm>
            <a:off x="7681963" y="1830792"/>
            <a:ext cx="1771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HSP90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8" name="图片 7" descr="模糊的照片&#10;&#10;描述已自动生成">
            <a:extLst>
              <a:ext uri="{FF2B5EF4-FFF2-40B4-BE49-F238E27FC236}">
                <a16:creationId xmlns:a16="http://schemas.microsoft.com/office/drawing/2014/main" id="{302D1B55-0D7C-4803-AFFC-476E5E3996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7332" y="2442325"/>
            <a:ext cx="5400000" cy="135672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EDE49155-5764-469E-BFD5-31A73850E7AF}"/>
              </a:ext>
            </a:extLst>
          </p:cNvPr>
          <p:cNvSpPr txBox="1"/>
          <p:nvPr/>
        </p:nvSpPr>
        <p:spPr>
          <a:xfrm>
            <a:off x="7681963" y="3131106"/>
            <a:ext cx="1771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YH2AX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8178771-60AC-4114-95B4-CD80FF25409A}"/>
              </a:ext>
            </a:extLst>
          </p:cNvPr>
          <p:cNvSpPr txBox="1"/>
          <p:nvPr/>
        </p:nvSpPr>
        <p:spPr>
          <a:xfrm>
            <a:off x="516082" y="628650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lot 219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12E4BA0-66CD-4CD8-B31E-400AC6861F75}"/>
              </a:ext>
            </a:extLst>
          </p:cNvPr>
          <p:cNvSpPr txBox="1"/>
          <p:nvPr/>
        </p:nvSpPr>
        <p:spPr>
          <a:xfrm>
            <a:off x="5127890" y="991385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18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AFFCC4A-59CE-4C81-A728-64E0047EE685}"/>
              </a:ext>
            </a:extLst>
          </p:cNvPr>
          <p:cNvSpPr txBox="1"/>
          <p:nvPr/>
        </p:nvSpPr>
        <p:spPr>
          <a:xfrm>
            <a:off x="2937055" y="991385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357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7438CC5-3015-4D88-9192-F6BC46EE10C0}"/>
              </a:ext>
            </a:extLst>
          </p:cNvPr>
          <p:cNvSpPr txBox="1"/>
          <p:nvPr/>
        </p:nvSpPr>
        <p:spPr>
          <a:xfrm>
            <a:off x="4064791" y="991385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24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C44FB8C-3C2F-4C65-8E68-C5D1FB0401F6}"/>
              </a:ext>
            </a:extLst>
          </p:cNvPr>
          <p:cNvSpPr txBox="1"/>
          <p:nvPr/>
        </p:nvSpPr>
        <p:spPr>
          <a:xfrm>
            <a:off x="6123470" y="991385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285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2A10081-A40B-4D6C-82A2-30C2848EAF57}"/>
              </a:ext>
            </a:extLst>
          </p:cNvPr>
          <p:cNvSpPr txBox="1"/>
          <p:nvPr/>
        </p:nvSpPr>
        <p:spPr>
          <a:xfrm>
            <a:off x="2927220" y="1433990"/>
            <a:ext cx="4640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Control  Curcumin   Control  Curcumin   Control  Curcumin   Control  Curcumin</a:t>
            </a:r>
            <a:endParaRPr lang="zh-CN" altLang="en-US" sz="1000" dirty="0"/>
          </a:p>
        </p:txBody>
      </p:sp>
      <p:sp>
        <p:nvSpPr>
          <p:cNvPr id="15" name="Textfeld 1">
            <a:extLst>
              <a:ext uri="{FF2B5EF4-FFF2-40B4-BE49-F238E27FC236}">
                <a16:creationId xmlns:a16="http://schemas.microsoft.com/office/drawing/2014/main" id="{2B95E4C6-A9FF-4F72-B963-77EAE7C09369}"/>
              </a:ext>
            </a:extLst>
          </p:cNvPr>
          <p:cNvSpPr txBox="1"/>
          <p:nvPr/>
        </p:nvSpPr>
        <p:spPr>
          <a:xfrm>
            <a:off x="3991479" y="121343"/>
            <a:ext cx="428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upplementary Materials</a:t>
            </a:r>
          </a:p>
        </p:txBody>
      </p:sp>
    </p:spTree>
    <p:extLst>
      <p:ext uri="{BB962C8B-B14F-4D97-AF65-F5344CB8AC3E}">
        <p14:creationId xmlns:p14="http://schemas.microsoft.com/office/powerpoint/2010/main" val="1487495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8976C8A-55E2-4897-AE10-8698C9308F1E}"/>
              </a:ext>
            </a:extLst>
          </p:cNvPr>
          <p:cNvSpPr txBox="1"/>
          <p:nvPr/>
        </p:nvSpPr>
        <p:spPr>
          <a:xfrm>
            <a:off x="516082" y="628650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lot 250</a:t>
            </a:r>
            <a:endParaRPr lang="zh-CN" altLang="en-US" dirty="0"/>
          </a:p>
        </p:txBody>
      </p:sp>
      <p:pic>
        <p:nvPicPr>
          <p:cNvPr id="6" name="图片 5" descr="水中的倒影&#10;&#10;描述已自动生成">
            <a:extLst>
              <a:ext uri="{FF2B5EF4-FFF2-40B4-BE49-F238E27FC236}">
                <a16:creationId xmlns:a16="http://schemas.microsoft.com/office/drawing/2014/main" id="{EDF9E647-EC7E-48FD-951E-AAAAC87C28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5081" y="1307426"/>
            <a:ext cx="6275337" cy="2083437"/>
          </a:xfrm>
          <a:prstGeom prst="rect">
            <a:avLst/>
          </a:prstGeom>
        </p:spPr>
      </p:pic>
      <p:pic>
        <p:nvPicPr>
          <p:cNvPr id="8" name="图片 7" descr="模糊的照片&#10;&#10;描述已自动生成">
            <a:extLst>
              <a:ext uri="{FF2B5EF4-FFF2-40B4-BE49-F238E27FC236}">
                <a16:creationId xmlns:a16="http://schemas.microsoft.com/office/drawing/2014/main" id="{6DE4FBE0-E1F3-4978-BC15-EC1A211C60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5082" y="3452964"/>
            <a:ext cx="5400000" cy="1211366"/>
          </a:xfrm>
          <a:prstGeom prst="rect">
            <a:avLst/>
          </a:prstGeom>
        </p:spPr>
      </p:pic>
      <p:pic>
        <p:nvPicPr>
          <p:cNvPr id="10" name="图片 9" descr="水中的倒影&#10;&#10;中度可信度描述已自动生成">
            <a:extLst>
              <a:ext uri="{FF2B5EF4-FFF2-40B4-BE49-F238E27FC236}">
                <a16:creationId xmlns:a16="http://schemas.microsoft.com/office/drawing/2014/main" id="{54E9F74F-2559-4087-A4F3-B9A53A552E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5082" y="4741840"/>
            <a:ext cx="5400000" cy="2018943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D64E37E-B0C8-4514-BD8E-52CBB2242A26}"/>
              </a:ext>
            </a:extLst>
          </p:cNvPr>
          <p:cNvSpPr txBox="1"/>
          <p:nvPr/>
        </p:nvSpPr>
        <p:spPr>
          <a:xfrm>
            <a:off x="2687523" y="1029594"/>
            <a:ext cx="4640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Control  Curcumin   Control  Curcumin   Control  Curcumin   Control  Curcumin</a:t>
            </a:r>
            <a:endParaRPr lang="zh-CN" altLang="en-US" sz="10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B019E01-40C2-426A-9687-7CC8BF71F0D0}"/>
              </a:ext>
            </a:extLst>
          </p:cNvPr>
          <p:cNvSpPr txBox="1"/>
          <p:nvPr/>
        </p:nvSpPr>
        <p:spPr>
          <a:xfrm>
            <a:off x="2837451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18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57C787F-8CE1-4D10-BFD0-12B76F1BBEE5}"/>
              </a:ext>
            </a:extLst>
          </p:cNvPr>
          <p:cNvSpPr txBox="1"/>
          <p:nvPr/>
        </p:nvSpPr>
        <p:spPr>
          <a:xfrm>
            <a:off x="3833031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285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673BCD6-C9DC-4817-8590-59DCA6B0D31A}"/>
              </a:ext>
            </a:extLst>
          </p:cNvPr>
          <p:cNvSpPr txBox="1"/>
          <p:nvPr/>
        </p:nvSpPr>
        <p:spPr>
          <a:xfrm>
            <a:off x="4899021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357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88EE98D-6180-4DFD-8173-B1039C15D4DD}"/>
              </a:ext>
            </a:extLst>
          </p:cNvPr>
          <p:cNvSpPr txBox="1"/>
          <p:nvPr/>
        </p:nvSpPr>
        <p:spPr>
          <a:xfrm>
            <a:off x="6017879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24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3C47DAF-B8B9-4D3F-ABDA-612FECB55A87}"/>
              </a:ext>
            </a:extLst>
          </p:cNvPr>
          <p:cNvSpPr txBox="1"/>
          <p:nvPr/>
        </p:nvSpPr>
        <p:spPr>
          <a:xfrm>
            <a:off x="8460418" y="2664793"/>
            <a:ext cx="1771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HSP90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7" name="Textfeld 7">
            <a:extLst>
              <a:ext uri="{FF2B5EF4-FFF2-40B4-BE49-F238E27FC236}">
                <a16:creationId xmlns:a16="http://schemas.microsoft.com/office/drawing/2014/main" id="{B8A9AB78-4613-4CED-B6E2-719D64206AF6}"/>
              </a:ext>
            </a:extLst>
          </p:cNvPr>
          <p:cNvSpPr txBox="1"/>
          <p:nvPr/>
        </p:nvSpPr>
        <p:spPr>
          <a:xfrm>
            <a:off x="8525341" y="4206826"/>
            <a:ext cx="1581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rgbClr val="FF0000"/>
                </a:solidFill>
              </a:rPr>
              <a:t>NFkB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18" name="Textfeld 13">
            <a:extLst>
              <a:ext uri="{FF2B5EF4-FFF2-40B4-BE49-F238E27FC236}">
                <a16:creationId xmlns:a16="http://schemas.microsoft.com/office/drawing/2014/main" id="{C995063D-3804-4218-BD86-C18FBCD7C20E}"/>
              </a:ext>
            </a:extLst>
          </p:cNvPr>
          <p:cNvSpPr txBox="1"/>
          <p:nvPr/>
        </p:nvSpPr>
        <p:spPr>
          <a:xfrm>
            <a:off x="8525341" y="5062449"/>
            <a:ext cx="21663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dirty="0" err="1">
                <a:solidFill>
                  <a:srgbClr val="FF0000"/>
                </a:solidFill>
              </a:rPr>
              <a:t>Survivin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19" name="Textfeld 1">
            <a:extLst>
              <a:ext uri="{FF2B5EF4-FFF2-40B4-BE49-F238E27FC236}">
                <a16:creationId xmlns:a16="http://schemas.microsoft.com/office/drawing/2014/main" id="{4C907D4F-5365-4A00-A55C-42C0DADAD60A}"/>
              </a:ext>
            </a:extLst>
          </p:cNvPr>
          <p:cNvSpPr txBox="1"/>
          <p:nvPr/>
        </p:nvSpPr>
        <p:spPr>
          <a:xfrm>
            <a:off x="3991479" y="121343"/>
            <a:ext cx="428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upplementary Materials</a:t>
            </a:r>
          </a:p>
        </p:txBody>
      </p:sp>
    </p:spTree>
    <p:extLst>
      <p:ext uri="{BB962C8B-B14F-4D97-AF65-F5344CB8AC3E}">
        <p14:creationId xmlns:p14="http://schemas.microsoft.com/office/powerpoint/2010/main" val="3596089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室内, 充满, 大, 鸟&#10;&#10;描述已自动生成">
            <a:extLst>
              <a:ext uri="{FF2B5EF4-FFF2-40B4-BE49-F238E27FC236}">
                <a16:creationId xmlns:a16="http://schemas.microsoft.com/office/drawing/2014/main" id="{762C5A0F-768D-41DE-8AE3-E779F933B4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995" y="1424214"/>
            <a:ext cx="5508736" cy="1225996"/>
          </a:xfrm>
          <a:prstGeom prst="rect">
            <a:avLst/>
          </a:prstGeom>
        </p:spPr>
      </p:pic>
      <p:pic>
        <p:nvPicPr>
          <p:cNvPr id="7" name="图片 6" descr="模糊的照片&#10;&#10;中度可信度描述已自动生成">
            <a:extLst>
              <a:ext uri="{FF2B5EF4-FFF2-40B4-BE49-F238E27FC236}">
                <a16:creationId xmlns:a16="http://schemas.microsoft.com/office/drawing/2014/main" id="{78D67CBF-3A15-4FD5-AC59-A00F517521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5995" y="2808542"/>
            <a:ext cx="5505184" cy="249187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2A318748-B1B0-4A84-8821-21A360488B4A}"/>
              </a:ext>
            </a:extLst>
          </p:cNvPr>
          <p:cNvSpPr txBox="1"/>
          <p:nvPr/>
        </p:nvSpPr>
        <p:spPr>
          <a:xfrm>
            <a:off x="516082" y="628650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lot 251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4929B39-A8AC-415B-AA73-93ED1F1FFAD2}"/>
              </a:ext>
            </a:extLst>
          </p:cNvPr>
          <p:cNvSpPr txBox="1"/>
          <p:nvPr/>
        </p:nvSpPr>
        <p:spPr>
          <a:xfrm>
            <a:off x="2687523" y="1029594"/>
            <a:ext cx="4640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Control  Curcumin   Control  Curcumin   Control  Curcumin   Control  Curcumin</a:t>
            </a:r>
            <a:endParaRPr lang="zh-CN" altLang="en-US" sz="10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BD1EBCE-47FB-4048-B3CA-D47BCEC9AFFD}"/>
              </a:ext>
            </a:extLst>
          </p:cNvPr>
          <p:cNvSpPr txBox="1"/>
          <p:nvPr/>
        </p:nvSpPr>
        <p:spPr>
          <a:xfrm>
            <a:off x="2837451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18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9870A73-C5A4-49DC-8952-E2DE7483F123}"/>
              </a:ext>
            </a:extLst>
          </p:cNvPr>
          <p:cNvSpPr txBox="1"/>
          <p:nvPr/>
        </p:nvSpPr>
        <p:spPr>
          <a:xfrm>
            <a:off x="3833031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285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EB49E56-75EC-4D83-9D9B-63DA581D9E72}"/>
              </a:ext>
            </a:extLst>
          </p:cNvPr>
          <p:cNvSpPr txBox="1"/>
          <p:nvPr/>
        </p:nvSpPr>
        <p:spPr>
          <a:xfrm>
            <a:off x="4899021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357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070E09A-2C24-4E84-8EB3-9E7708AC5FB9}"/>
              </a:ext>
            </a:extLst>
          </p:cNvPr>
          <p:cNvSpPr txBox="1"/>
          <p:nvPr/>
        </p:nvSpPr>
        <p:spPr>
          <a:xfrm>
            <a:off x="6017879" y="628650"/>
            <a:ext cx="115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ROC24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907B35B-1F5E-43DB-A020-3F7DF55E5C84}"/>
              </a:ext>
            </a:extLst>
          </p:cNvPr>
          <p:cNvSpPr txBox="1"/>
          <p:nvPr/>
        </p:nvSpPr>
        <p:spPr>
          <a:xfrm>
            <a:off x="7911855" y="3766178"/>
            <a:ext cx="1771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BCL-XL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03F904A-D7DD-4B40-B131-1187D6C2BBDD}"/>
              </a:ext>
            </a:extLst>
          </p:cNvPr>
          <p:cNvSpPr txBox="1"/>
          <p:nvPr/>
        </p:nvSpPr>
        <p:spPr>
          <a:xfrm>
            <a:off x="7911855" y="2170564"/>
            <a:ext cx="1771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HSP90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2B86FE8-05C5-47D4-8AD4-582DCF2F0401}"/>
              </a:ext>
            </a:extLst>
          </p:cNvPr>
          <p:cNvSpPr txBox="1"/>
          <p:nvPr/>
        </p:nvSpPr>
        <p:spPr>
          <a:xfrm>
            <a:off x="7911855" y="4477378"/>
            <a:ext cx="1771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YH2AX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7" name="Textfeld 1">
            <a:extLst>
              <a:ext uri="{FF2B5EF4-FFF2-40B4-BE49-F238E27FC236}">
                <a16:creationId xmlns:a16="http://schemas.microsoft.com/office/drawing/2014/main" id="{4F44DC22-CD24-48AD-907C-A84D29D06B65}"/>
              </a:ext>
            </a:extLst>
          </p:cNvPr>
          <p:cNvSpPr txBox="1"/>
          <p:nvPr/>
        </p:nvSpPr>
        <p:spPr>
          <a:xfrm>
            <a:off x="3991479" y="121343"/>
            <a:ext cx="428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upplementary Materials</a:t>
            </a:r>
          </a:p>
        </p:txBody>
      </p:sp>
    </p:spTree>
    <p:extLst>
      <p:ext uri="{BB962C8B-B14F-4D97-AF65-F5344CB8AC3E}">
        <p14:creationId xmlns:p14="http://schemas.microsoft.com/office/powerpoint/2010/main" val="4379913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56</Words>
  <Application>Microsoft Office PowerPoint</Application>
  <PresentationFormat>宽屏</PresentationFormat>
  <Paragraphs>2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elanie Dzulko</dc:creator>
  <cp:lastModifiedBy>Lili Lu</cp:lastModifiedBy>
  <cp:revision>35</cp:revision>
  <cp:lastPrinted>2021-04-19T09:49:55Z</cp:lastPrinted>
  <dcterms:created xsi:type="dcterms:W3CDTF">2021-03-26T12:13:06Z</dcterms:created>
  <dcterms:modified xsi:type="dcterms:W3CDTF">2022-02-15T08:46:45Z</dcterms:modified>
</cp:coreProperties>
</file>